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8" r:id="rId2"/>
    <p:sldId id="26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vertBarState="minimized" horzBarState="maximized">
    <p:restoredLeft sz="7029"/>
    <p:restoredTop sz="96327"/>
  </p:normalViewPr>
  <p:slideViewPr>
    <p:cSldViewPr snapToGrid="0">
      <p:cViewPr varScale="1">
        <p:scale>
          <a:sx n="128" d="100"/>
          <a:sy n="128" d="100"/>
        </p:scale>
        <p:origin x="14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F9B81F-FBFF-544C-BC15-755BBD1CE538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D68037-5322-1747-905E-F5C0D615E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30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8D04CD-C028-2462-9074-FE87BDBA1F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68CE205-C6FB-C587-9002-1C40FC82DA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242AEC-844A-E26A-BD84-34E085991D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0C1452-8C1A-EB84-BE24-7124CE623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388550-C7E9-9CC0-A591-655CD6F4C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72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01829E-E0C9-542A-A4FE-CEF8B7B06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F2C9E02-41B4-5719-489E-B11D19AD71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E081A6-9B21-73C3-771D-CD4EF2B00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5AD72C-00A5-4C0B-20E3-66C957607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4518E4-9457-02C6-42F9-52FF805FA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69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D068F83-1A1F-762D-6265-211B65200F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6FE73DC-75F7-D668-88A6-68C7F9DB65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5AC606A-7188-03CF-B676-FC6536973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A2F3AA-381B-99B5-4337-11F0FC9C6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6616CF-C5E2-1A69-7654-7725174EE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601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019665-244D-1872-21B3-9B9E16D845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D866F9-3384-4325-0143-DDC0D2024F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2828AE-3F0E-9048-63F5-E35852CA6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3BA0CC-0695-D7C3-B91D-C055E6A8A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6EFA98-FDEB-ED83-FEB6-C6263F66B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511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4D4556-CB8D-669C-C8B9-898D5CF9F7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47322F-85D4-6495-21E0-16CE59B337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675090-A76D-E0CA-FD73-16645FD8B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EDD0B4-4AD6-8B81-5E29-EBAD95BDE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DC95CF-1498-D435-3268-F4F370281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201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7BF84B-147B-5F47-957C-C36C19F89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382878C-DF08-B621-00BD-0033D24311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F95D6C0-A707-7A49-DAA6-C2DDB37C4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6BC1305-BF54-582C-7364-06C131B83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B4ADA3-9AF5-DF26-3CEF-03829822E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01178A-934C-8BC7-181E-BF805715E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7075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49BE9-6442-64C1-6992-09C2FFA77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D600DAB-6184-32F4-EF79-08D51029D4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056964E-191C-27B2-B12E-2D76A0610F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9CE868D-36C5-5869-80EF-DF2BEB514B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CEF4373-C261-0C60-961E-4E24556586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9C3512-761C-CA6F-801A-9645353EA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73937A3-949E-9790-EA83-2A5E83674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72C350B-52B2-7AE7-A2E5-95EB1B98C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288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F33016-75ED-1C0F-49A2-90440FE97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0562B5F-08CE-4249-4776-6C379EC5D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CC2E7AE-0424-78CA-B674-BFBE4F5FB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AD9E4DD-DDDA-DD8D-705E-21F78F34F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444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826AD33-A1AC-FF52-E6F7-DCEC2DFA7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A80B88-3CA8-77DF-3CF7-3A62612AA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BE1332C-F8E5-8B32-E7ED-E0CC1E854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36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5EBA5E-078B-EA2E-2403-FA826AE5F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AF6414-4661-DDB3-71F6-CF2770D2FF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3C6304B-4990-02E8-2685-FA1B8BC05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631B69-A507-884D-C823-99E230EDF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11B673-6867-D6DC-305E-90229442F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2F497B-3EED-C31C-3B1E-79C63397D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334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C8AEA0-AF85-377A-0FAC-41EF66B84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CD44179-D12D-A457-4761-4E8DF847D4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50208B7-FD00-7975-AF38-284E45ACBD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0652B91-F3EF-65AA-B034-9FC31C3F5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D7273AC-EFE6-0CD2-5776-08993B040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06026AD-B7D6-922B-FB58-9DF36BA1E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509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41E5CD0-9714-5415-5266-9B776230D8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820143-D207-18C3-8F96-642886A966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A300F1-539B-CE8C-005D-9C02ED61DF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617F3-17DA-9742-83EC-02B3E81A4536}" type="datetimeFigureOut">
              <a:rPr kumimoji="1" lang="ja-JP" altLang="en-US" smtClean="0"/>
              <a:t>2023/11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C1187C-0F9C-3D48-CCC3-4B8E76BF5B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D0AC76-44F5-2BA7-CD14-B58B95896F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646C9-C067-6B40-A42E-D1B050992E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82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表 4">
            <a:extLst>
              <a:ext uri="{FF2B5EF4-FFF2-40B4-BE49-F238E27FC236}">
                <a16:creationId xmlns:a16="http://schemas.microsoft.com/office/drawing/2014/main" id="{F6E45869-CBA3-3D8E-6A49-A04E0D3467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1744355"/>
              </p:ext>
            </p:extLst>
          </p:nvPr>
        </p:nvGraphicFramePr>
        <p:xfrm>
          <a:off x="5121084" y="4903557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graphicFrame>
        <p:nvGraphicFramePr>
          <p:cNvPr id="23" name="表 4">
            <a:extLst>
              <a:ext uri="{FF2B5EF4-FFF2-40B4-BE49-F238E27FC236}">
                <a16:creationId xmlns:a16="http://schemas.microsoft.com/office/drawing/2014/main" id="{EA455CD6-5DE4-8051-5771-8681DAC6B2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8685563"/>
              </p:ext>
            </p:extLst>
          </p:nvPr>
        </p:nvGraphicFramePr>
        <p:xfrm>
          <a:off x="1866496" y="4914099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graphicFrame>
        <p:nvGraphicFramePr>
          <p:cNvPr id="24" name="表 4">
            <a:extLst>
              <a:ext uri="{FF2B5EF4-FFF2-40B4-BE49-F238E27FC236}">
                <a16:creationId xmlns:a16="http://schemas.microsoft.com/office/drawing/2014/main" id="{E0E1E84B-E125-E06F-5C84-1DFF8D5C44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8235873"/>
              </p:ext>
            </p:extLst>
          </p:nvPr>
        </p:nvGraphicFramePr>
        <p:xfrm>
          <a:off x="8211696" y="4914099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E12044-FBBE-0D99-EFD1-7182907906BC}"/>
              </a:ext>
            </a:extLst>
          </p:cNvPr>
          <p:cNvSpPr txBox="1"/>
          <p:nvPr/>
        </p:nvSpPr>
        <p:spPr>
          <a:xfrm>
            <a:off x="763712" y="351135"/>
            <a:ext cx="31133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61B90F2-C1E5-3DAD-7A21-882B09CE23CD}"/>
              </a:ext>
            </a:extLst>
          </p:cNvPr>
          <p:cNvSpPr txBox="1"/>
          <p:nvPr/>
        </p:nvSpPr>
        <p:spPr>
          <a:xfrm>
            <a:off x="777759" y="783594"/>
            <a:ext cx="93357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. Ig against WSP at 12w, 24w, 36w, and 48w following vaccination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1AEFA05-45A2-B6BE-68D2-C3C165A79AA2}"/>
              </a:ext>
            </a:extLst>
          </p:cNvPr>
          <p:cNvSpPr txBox="1"/>
          <p:nvPr/>
        </p:nvSpPr>
        <p:spPr>
          <a:xfrm>
            <a:off x="880823" y="26910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5D01F97-64E7-E499-E628-10CC9040B349}"/>
              </a:ext>
            </a:extLst>
          </p:cNvPr>
          <p:cNvSpPr txBox="1"/>
          <p:nvPr/>
        </p:nvSpPr>
        <p:spPr>
          <a:xfrm rot="16200000">
            <a:off x="849457" y="3815396"/>
            <a:ext cx="939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G (WSP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13AC446-A485-DA9C-DDCE-F63FF5185DFC}"/>
              </a:ext>
            </a:extLst>
          </p:cNvPr>
          <p:cNvSpPr txBox="1"/>
          <p:nvPr/>
        </p:nvSpPr>
        <p:spPr>
          <a:xfrm>
            <a:off x="4135191" y="26656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1869BF1-AD45-EAC4-9D23-D6C2F0BAC0FB}"/>
              </a:ext>
            </a:extLst>
          </p:cNvPr>
          <p:cNvSpPr txBox="1"/>
          <p:nvPr/>
        </p:nvSpPr>
        <p:spPr>
          <a:xfrm rot="16200000">
            <a:off x="4099818" y="3789996"/>
            <a:ext cx="9476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M (WSP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007124D-C81F-66CA-A3A3-11CC625D3DAD}"/>
              </a:ext>
            </a:extLst>
          </p:cNvPr>
          <p:cNvSpPr txBox="1"/>
          <p:nvPr/>
        </p:nvSpPr>
        <p:spPr>
          <a:xfrm>
            <a:off x="7203283" y="26656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A64E674-584D-5BF6-803D-604AE6188CAA}"/>
              </a:ext>
            </a:extLst>
          </p:cNvPr>
          <p:cNvSpPr txBox="1"/>
          <p:nvPr/>
        </p:nvSpPr>
        <p:spPr>
          <a:xfrm rot="16200000">
            <a:off x="7179580" y="3789996"/>
            <a:ext cx="924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A (WSP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9290F455-7669-B3E9-B27A-453F295FB3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182" t="10873" r="23235" b="5010"/>
          <a:stretch/>
        </p:blipFill>
        <p:spPr>
          <a:xfrm>
            <a:off x="880823" y="1972491"/>
            <a:ext cx="2996242" cy="298051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EC3F9669-7577-4623-5D2D-1419982993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563" t="11780" r="23623" b="6354"/>
          <a:stretch/>
        </p:blipFill>
        <p:spPr>
          <a:xfrm>
            <a:off x="4192041" y="2665645"/>
            <a:ext cx="2996242" cy="2287356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7697D7BA-2100-95D1-1C8D-DF700086FAB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613" t="14716" r="27578" b="6919"/>
          <a:stretch/>
        </p:blipFill>
        <p:spPr>
          <a:xfrm>
            <a:off x="7503259" y="2942644"/>
            <a:ext cx="2610262" cy="2010358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8918967-5ED7-44D9-8550-606D9EC1BF68}"/>
              </a:ext>
            </a:extLst>
          </p:cNvPr>
          <p:cNvSpPr txBox="1"/>
          <p:nvPr/>
        </p:nvSpPr>
        <p:spPr>
          <a:xfrm>
            <a:off x="9495438" y="2942642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2620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表 4">
            <a:extLst>
              <a:ext uri="{FF2B5EF4-FFF2-40B4-BE49-F238E27FC236}">
                <a16:creationId xmlns:a16="http://schemas.microsoft.com/office/drawing/2014/main" id="{7EDCD65D-A3D9-A890-B5B9-3912584511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964444"/>
              </p:ext>
            </p:extLst>
          </p:nvPr>
        </p:nvGraphicFramePr>
        <p:xfrm>
          <a:off x="1865450" y="4896305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graphicFrame>
        <p:nvGraphicFramePr>
          <p:cNvPr id="20" name="表 4">
            <a:extLst>
              <a:ext uri="{FF2B5EF4-FFF2-40B4-BE49-F238E27FC236}">
                <a16:creationId xmlns:a16="http://schemas.microsoft.com/office/drawing/2014/main" id="{F4B19060-C093-C0C8-807C-2B8A1B076B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2208444"/>
              </p:ext>
            </p:extLst>
          </p:nvPr>
        </p:nvGraphicFramePr>
        <p:xfrm>
          <a:off x="8191466" y="4896305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graphicFrame>
        <p:nvGraphicFramePr>
          <p:cNvPr id="18" name="表 4">
            <a:extLst>
              <a:ext uri="{FF2B5EF4-FFF2-40B4-BE49-F238E27FC236}">
                <a16:creationId xmlns:a16="http://schemas.microsoft.com/office/drawing/2014/main" id="{F722FCE0-E26B-7462-A3AB-E42EB3863F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2005248"/>
              </p:ext>
            </p:extLst>
          </p:nvPr>
        </p:nvGraphicFramePr>
        <p:xfrm>
          <a:off x="4971382" y="4903557"/>
          <a:ext cx="168828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2070">
                  <a:extLst>
                    <a:ext uri="{9D8B030D-6E8A-4147-A177-3AD203B41FA5}">
                      <a16:colId xmlns:a16="http://schemas.microsoft.com/office/drawing/2014/main" val="281038207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1601811936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95306377"/>
                    </a:ext>
                  </a:extLst>
                </a:gridCol>
                <a:gridCol w="422070">
                  <a:extLst>
                    <a:ext uri="{9D8B030D-6E8A-4147-A177-3AD203B41FA5}">
                      <a16:colId xmlns:a16="http://schemas.microsoft.com/office/drawing/2014/main" val="379248925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5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6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7</a:t>
                      </a:r>
                      <a:endParaRPr kumimoji="1" lang="ja-JP" altLang="en-US" sz="1200" b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8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36816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AA64050-FCB2-2257-B7F7-36A939566BEE}"/>
              </a:ext>
            </a:extLst>
          </p:cNvPr>
          <p:cNvSpPr txBox="1"/>
          <p:nvPr/>
        </p:nvSpPr>
        <p:spPr>
          <a:xfrm>
            <a:off x="763712" y="351135"/>
            <a:ext cx="31133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630CAC1-331E-3140-B39F-43AA056B00D8}"/>
              </a:ext>
            </a:extLst>
          </p:cNvPr>
          <p:cNvSpPr txBox="1"/>
          <p:nvPr/>
        </p:nvSpPr>
        <p:spPr>
          <a:xfrm>
            <a:off x="777759" y="783594"/>
            <a:ext cx="90175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B. Ig against S1 at 12w, 24w, 36w, and 48w following vaccination</a:t>
            </a:r>
            <a:endParaRPr kumimoji="1"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B6ECB30-FE4C-2C58-1326-4B79D3C65D2A}"/>
              </a:ext>
            </a:extLst>
          </p:cNvPr>
          <p:cNvSpPr txBox="1"/>
          <p:nvPr/>
        </p:nvSpPr>
        <p:spPr>
          <a:xfrm>
            <a:off x="880823" y="26910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5B83114-FB7B-5C2D-C5B3-E9DE62C1F131}"/>
              </a:ext>
            </a:extLst>
          </p:cNvPr>
          <p:cNvSpPr txBox="1"/>
          <p:nvPr/>
        </p:nvSpPr>
        <p:spPr>
          <a:xfrm rot="16200000">
            <a:off x="931210" y="3815396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G (S1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98D5C12-4C01-6979-D367-B26B3444B22F}"/>
              </a:ext>
            </a:extLst>
          </p:cNvPr>
          <p:cNvSpPr txBox="1"/>
          <p:nvPr/>
        </p:nvSpPr>
        <p:spPr>
          <a:xfrm>
            <a:off x="3982049" y="26910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C22BD66-5D9D-9D72-4071-A51D37170E88}"/>
              </a:ext>
            </a:extLst>
          </p:cNvPr>
          <p:cNvSpPr txBox="1"/>
          <p:nvPr/>
        </p:nvSpPr>
        <p:spPr>
          <a:xfrm rot="16200000">
            <a:off x="4028429" y="3815396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M (S1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E53297D-0998-F0A8-A230-9AA6A2BE2CF6}"/>
              </a:ext>
            </a:extLst>
          </p:cNvPr>
          <p:cNvSpPr txBox="1"/>
          <p:nvPr/>
        </p:nvSpPr>
        <p:spPr>
          <a:xfrm>
            <a:off x="7264510" y="2691045"/>
            <a:ext cx="1023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ng/mL (log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6E4C8F6-E727-28B7-3CCD-57680B5CBAB7}"/>
              </a:ext>
            </a:extLst>
          </p:cNvPr>
          <p:cNvSpPr txBox="1"/>
          <p:nvPr/>
        </p:nvSpPr>
        <p:spPr>
          <a:xfrm rot="16200000">
            <a:off x="7310890" y="3815396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gA (S1)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E51BF237-8602-7F4F-C3F5-28570EB7D3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923" t="13005" r="26789" b="5381"/>
          <a:stretch/>
        </p:blipFill>
        <p:spPr>
          <a:xfrm>
            <a:off x="1525978" y="2351313"/>
            <a:ext cx="2196935" cy="2643053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D9831F6E-B1B3-8B34-6A39-C72A3CA7F44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324" t="14221" r="25680" b="6793"/>
          <a:stretch/>
        </p:blipFill>
        <p:spPr>
          <a:xfrm>
            <a:off x="4683731" y="2968044"/>
            <a:ext cx="2196935" cy="2026322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119273D-A4B1-33EC-4338-07E812885E9B}"/>
              </a:ext>
            </a:extLst>
          </p:cNvPr>
          <p:cNvSpPr txBox="1"/>
          <p:nvPr/>
        </p:nvSpPr>
        <p:spPr>
          <a:xfrm>
            <a:off x="4833987" y="3071050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3E557071-F8B1-3638-82CC-EAB2264BC50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463" t="11482" r="27104" b="4675"/>
          <a:stretch/>
        </p:blipFill>
        <p:spPr>
          <a:xfrm>
            <a:off x="7841484" y="2012867"/>
            <a:ext cx="2196935" cy="29814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821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</TotalTime>
  <Words>128</Words>
  <Application>Microsoft Macintosh PowerPoint</Application>
  <PresentationFormat>ワイド画面</PresentationFormat>
  <Paragraphs>4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ji Ota</dc:creator>
  <cp:lastModifiedBy>Kenji Ota</cp:lastModifiedBy>
  <cp:revision>9</cp:revision>
  <cp:lastPrinted>2023-10-31T02:08:18Z</cp:lastPrinted>
  <dcterms:created xsi:type="dcterms:W3CDTF">2023-10-26T08:25:04Z</dcterms:created>
  <dcterms:modified xsi:type="dcterms:W3CDTF">2023-11-02T09:01:47Z</dcterms:modified>
</cp:coreProperties>
</file>